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73A47A-6C3D-44EA-8E60-1713A9F344C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1C8DBF4-D6F8-430B-9EEE-27614D202A0D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FB3CA-EEFB-4FC4-8DAF-0662B1A281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570077-C8AB-4662-8EEF-1B9BCCA599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A3EE1A-0D80-4A4E-B1DC-77D2197ACB8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1E5231-936B-4737-A5A6-6FF9FD374F0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A57D30-5AA7-4809-94AA-5CDE29C824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F4C78D-DA09-4ED3-8388-8E896D053B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A4227E-5285-4A21-A62C-59819CA6B1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619DC1-246B-4265-8EC4-3248071890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4F47B2-5295-46B5-B9DD-A248FA36EB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4EFAB6-6DD8-4974-AD78-E968B6406E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3B1EE-A454-4D77-A54E-430D2632B0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016138-576B-45EF-B39A-7437E17240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5CCBCC-E7B7-4472-9B82-DF0DEBEF63E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5"/>
          <p:cNvSpPr/>
          <p:nvPr/>
        </p:nvSpPr>
        <p:spPr>
          <a:xfrm rot="16200000">
            <a:off x="-247320" y="1626120"/>
            <a:ext cx="1471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Relative Gene Express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Object 6" descr=""/>
          <p:cNvPicPr/>
          <p:nvPr/>
        </p:nvPicPr>
        <p:blipFill>
          <a:blip r:embed="rId1"/>
          <a:stretch/>
        </p:blipFill>
        <p:spPr>
          <a:xfrm>
            <a:off x="609480" y="762120"/>
            <a:ext cx="3505320" cy="2295360"/>
          </a:xfrm>
          <a:prstGeom prst="rect">
            <a:avLst/>
          </a:prstGeom>
          <a:ln w="0">
            <a:noFill/>
          </a:ln>
        </p:spPr>
      </p:pic>
      <p:sp>
        <p:nvSpPr>
          <p:cNvPr id="50" name="TextBox 5"/>
          <p:cNvSpPr/>
          <p:nvPr/>
        </p:nvSpPr>
        <p:spPr>
          <a:xfrm>
            <a:off x="10440" y="0"/>
            <a:ext cx="239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7"/>
          <p:cNvSpPr/>
          <p:nvPr/>
        </p:nvSpPr>
        <p:spPr>
          <a:xfrm>
            <a:off x="307080" y="614520"/>
            <a:ext cx="3286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8"/>
          <p:cNvSpPr/>
          <p:nvPr/>
        </p:nvSpPr>
        <p:spPr>
          <a:xfrm>
            <a:off x="311760" y="3029040"/>
            <a:ext cx="319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Chart 10" descr=""/>
          <p:cNvPicPr/>
          <p:nvPr/>
        </p:nvPicPr>
        <p:blipFill>
          <a:blip r:embed="rId2"/>
          <a:stretch/>
        </p:blipFill>
        <p:spPr>
          <a:xfrm>
            <a:off x="549360" y="3273480"/>
            <a:ext cx="3363840" cy="1762200"/>
          </a:xfrm>
          <a:prstGeom prst="rect">
            <a:avLst/>
          </a:prstGeom>
          <a:ln w="0">
            <a:noFill/>
          </a:ln>
        </p:spPr>
      </p:pic>
      <p:sp>
        <p:nvSpPr>
          <p:cNvPr id="54" name="Text Box 5"/>
          <p:cNvSpPr/>
          <p:nvPr/>
        </p:nvSpPr>
        <p:spPr>
          <a:xfrm rot="16200000">
            <a:off x="-231480" y="3861360"/>
            <a:ext cx="1471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Relative Gene Express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2"/>
          <p:cNvSpPr/>
          <p:nvPr/>
        </p:nvSpPr>
        <p:spPr>
          <a:xfrm>
            <a:off x="152280" y="5073480"/>
            <a:ext cx="4343400" cy="176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Supplementary Figure 1. Upregulation of Rgs5 and PSENEN by sEphB4-Alb. </a:t>
            </a:r>
            <a:r>
              <a:rPr b="0" i="1" lang="en-US" sz="1100" spc="-1" strike="noStrike">
                <a:solidFill>
                  <a:srgbClr val="000000"/>
                </a:solidFill>
                <a:latin typeface="Calibri"/>
              </a:rPr>
              <a:t>A.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 Total RNA  used for global gene analysis (Table 1) was used to validate upregulation of Rgs5 and PSENEN. Gene expression level was normalized to </a:t>
            </a:r>
            <a:r>
              <a:rPr b="0" lang="en-US" sz="11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-actin. Another housekeeping gene GAPDH was also included in this analysis.  </a:t>
            </a:r>
            <a:r>
              <a:rPr b="0" i="1" lang="en-US" sz="1100" spc="-1" strike="noStrike">
                <a:solidFill>
                  <a:srgbClr val="000000"/>
                </a:solidFill>
                <a:latin typeface="Calibri"/>
              </a:rPr>
              <a:t>B.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 Human umbilical artery endothelial cells and smooth muscle cells (both from Lonza) were co-cultured (1:1) for overnight, followed by treatment with sEphB4-Alb (10 ug/ml) for 6 hours. Cells were harvested and total RNA was isolated for quantitative RT-PCR. Gene expression level was normalized to </a:t>
            </a:r>
            <a:r>
              <a:rPr b="0" lang="en-US" sz="11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-actin. Another housekeeping gene GAPDH was also included in this analysis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30T16:24:30Z</dcterms:created>
  <dc:creator>Ren</dc:creator>
  <dc:description/>
  <dc:language>en-US</dc:language>
  <cp:lastModifiedBy>Ren</cp:lastModifiedBy>
  <dcterms:modified xsi:type="dcterms:W3CDTF">2010-10-01T16:33:52Z</dcterms:modified>
  <cp:revision>7</cp:revision>
  <dc:subject/>
  <dc:title>Validation of Rgs5 and PSENEN Regulation </dc:title>
</cp:coreProperties>
</file>